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63" r:id="rId2"/>
    <p:sldId id="261" r:id="rId3"/>
    <p:sldId id="262" r:id="rId4"/>
    <p:sldId id="264" r:id="rId5"/>
    <p:sldId id="257" r:id="rId6"/>
    <p:sldId id="258" r:id="rId7"/>
    <p:sldId id="259" r:id="rId8"/>
    <p:sldId id="260" r:id="rId9"/>
    <p:sldId id="265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8" d="100"/>
          <a:sy n="78" d="100"/>
        </p:scale>
        <p:origin x="1512" y="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562FE6-0800-8F4F-8D55-65E922A64F8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98675C-4CDE-3D44-8945-A3FDFEC00F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4249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43347F-BA8E-9244-B6C3-12EA710FFA4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70170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43347F-BA8E-9244-B6C3-12EA710FFA4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7643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43347F-BA8E-9244-B6C3-12EA710FFA48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530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43347F-BA8E-9244-B6C3-12EA710FFA4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8607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566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762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4311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662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966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402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396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45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446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232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530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65C01-1A6E-2F4B-BBA0-6106695470E4}" type="datetimeFigureOut">
              <a:rPr lang="en-US" smtClean="0"/>
              <a:t>2/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85DA98-49AD-7541-B9B0-716B1AB1D9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549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54" y="127000"/>
            <a:ext cx="6858000" cy="890575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287390" y="69334"/>
            <a:ext cx="25549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1</a:t>
            </a:r>
            <a:r>
              <a:rPr lang="en-US" dirty="0" smtClean="0"/>
              <a:t>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89144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2737"/>
            <a:ext cx="6858000" cy="877852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184650" y="57666"/>
            <a:ext cx="2546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</a:t>
            </a:r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65302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43968"/>
            <a:ext cx="6858000" cy="8856063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4168775" y="69334"/>
            <a:ext cx="2544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</a:t>
            </a:r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518195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1405"/>
            <a:ext cx="6858000" cy="896576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168775" y="69334"/>
            <a:ext cx="2563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</a:t>
            </a:r>
            <a:r>
              <a:rPr lang="en-US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6596738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3009900" y="254000"/>
            <a:ext cx="25549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2</a:t>
            </a:r>
            <a:r>
              <a:rPr lang="en-US" dirty="0" smtClean="0"/>
              <a:t>A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1850" y="1163764"/>
            <a:ext cx="6204958" cy="64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248313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009900" y="254000"/>
            <a:ext cx="2546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</a:t>
            </a:r>
            <a:r>
              <a:rPr lang="en-US" dirty="0" smtClean="0"/>
              <a:t>Figure </a:t>
            </a:r>
            <a:r>
              <a:rPr lang="en-US" dirty="0"/>
              <a:t>2</a:t>
            </a:r>
            <a:r>
              <a:rPr lang="en-US" dirty="0" smtClean="0"/>
              <a:t>B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8667" y="1181100"/>
            <a:ext cx="6381667" cy="63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52232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3009900" y="254000"/>
            <a:ext cx="2544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2C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468" y="1121833"/>
            <a:ext cx="6152727" cy="64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34882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009900" y="254000"/>
            <a:ext cx="25634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</a:t>
            </a:r>
            <a:r>
              <a:rPr lang="en-US" dirty="0" smtClean="0"/>
              <a:t>2D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9979" y="1143000"/>
            <a:ext cx="6311623" cy="63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873326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Supplementary Fig 3.ti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600" y="1584054"/>
            <a:ext cx="6400800" cy="513892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009900" y="254000"/>
            <a:ext cx="242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7788202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31</Words>
  <Application>Microsoft Office PowerPoint</Application>
  <PresentationFormat>Letter Paper (8.5x11 in)</PresentationFormat>
  <Paragraphs>13</Paragraphs>
  <Slides>9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ime Modiano</dc:creator>
  <cp:lastModifiedBy>Theo Isaac</cp:lastModifiedBy>
  <cp:revision>6</cp:revision>
  <dcterms:created xsi:type="dcterms:W3CDTF">2014-12-20T21:44:42Z</dcterms:created>
  <dcterms:modified xsi:type="dcterms:W3CDTF">2017-02-01T12:26:15Z</dcterms:modified>
</cp:coreProperties>
</file>